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CB25A7-2621-4718-91F9-406F5B74C664}" type="slidenum">
              <a:rPr b="0" lang="ko-KR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7" name="슬라이드 번호 개체 틀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20BEC0-5758-4865-8C20-2051A0406F88}" type="slidenum">
              <a:rPr b="0" lang="ko-KR" sz="1200" spc="-1" strike="noStrike">
                <a:solidFill>
                  <a:srgbClr val="000000"/>
                </a:solidFill>
                <a:latin typeface="굴림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9C29B-4198-41CE-A14B-1CF077F74F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46627-2D8C-48D3-9BC8-38ECF4A039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01BD7-20DC-4D34-BE43-9972C5F5C1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9E613-09F0-49A0-98CE-FAC115BDF6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22037-648C-41FF-893A-3AF1BBAF64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954E8-E9ED-4710-B179-9C3257721B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B1897-71A7-4846-8922-AEEAA27087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CC384-F1FD-40E3-BF2E-5DBA1670D4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93091-C7A3-4BE9-A6B2-6D972A332B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6CF6C-2DD5-4F45-9B4C-8749AEC1F6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B6BFF-2464-42E1-94F0-1A391C9E70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3B2A7-A7CD-4037-8895-B5498746D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12C826-9015-4317-BC5D-B5BCCD6B445A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717480" y="1623960"/>
          <a:ext cx="7704360" cy="4430880"/>
        </p:xfrm>
        <a:graphic>
          <a:graphicData uri="http://schemas.openxmlformats.org/drawingml/2006/table">
            <a:tbl>
              <a:tblPr/>
              <a:tblGrid>
                <a:gridCol w="304920"/>
                <a:gridCol w="228600"/>
                <a:gridCol w="979560"/>
                <a:gridCol w="215640"/>
                <a:gridCol w="1150920"/>
                <a:gridCol w="216000"/>
                <a:gridCol w="1622520"/>
                <a:gridCol w="235080"/>
                <a:gridCol w="1730160"/>
                <a:gridCol w="230400"/>
                <a:gridCol w="790560"/>
              </a:tblGrid>
              <a:tr h="58500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o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Primer &amp; Gen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36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Genbank Accession Numb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Primer Sequ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36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36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Size (bp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360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360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Sen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360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Antisen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360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360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OVG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07696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catcacggttcaccgctat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aattccaccggtcgtgtg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BC0485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d0d0d"/>
                          </a:solidFill>
                          <a:latin typeface="굴림"/>
                          <a:ea typeface="바탕체"/>
                        </a:rPr>
                        <a:t>NM_001001179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agattgtgcagtggcttgc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gctcagcgtgatggtgttt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Tmem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28097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tgcggaccttcttaggtg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tgttccccggtatccttt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Dcp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1991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agagcacatcattgcagcc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ctgggatcgttagggaagct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Prkg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08926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agagcacatcattgcagcc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gggatcgttagggaagct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Edn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07902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gctcctgctgctgtgttaa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gtatgcagggatggccttt-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Adamts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09621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ggcagccaggttttacaa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aattccgaagggtgagagc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Akr1b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0973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ccaaaggaatgtggtggt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ccagttcctgttgaagctg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Tex19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27622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cagaatgcacctgaacagc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acgaatgcaccttgaagcc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Sectm1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23854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catattcaaggaggccag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ctgcggcattaacaatcag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Cts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194055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caagcttggcatctttcca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tccagtgcttgcttccctt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Gpnm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XM_001476835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caacgactctgccatttcc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ttgcacggtgaggttaagg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Sectm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NM_009113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ctgtctgccaatggaaagg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cgtcctgggtgtctttgat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Hsd17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d0d0d"/>
                          </a:solidFill>
                          <a:latin typeface="굴림"/>
                          <a:ea typeface="바탕체"/>
                        </a:rPr>
                        <a:t>NM_010475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tcgaaggtttgtgcgagagt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gcccaccagcttttcataga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5280"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l-GR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β</a:t>
                      </a:r>
                      <a:r>
                        <a:rPr b="1" lang="el-GR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-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act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agagggaaatcgtgcgtgac-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5′-caatagtgatgacctggccgt-3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just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12600" anchor="ctr">
                      <a:noAutofit/>
                    </a:bodyPr>
                    <a:p>
                      <a:pPr algn="ctr">
                        <a:lnSpc>
                          <a:spcPct val="1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굴림"/>
                          <a:ea typeface="바탕체"/>
                        </a:rPr>
                        <a:t>1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TextBox 18"/>
          <p:cNvSpPr/>
          <p:nvPr/>
        </p:nvSpPr>
        <p:spPr>
          <a:xfrm>
            <a:off x="268200" y="115920"/>
            <a:ext cx="4252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HY견고딕"/>
                <a:ea typeface="HY견고딕"/>
              </a:rPr>
              <a:t>Supplementary Table 1</a:t>
            </a:r>
            <a:endParaRPr b="0" lang="en-US" sz="2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Rectangle 1"/>
          <p:cNvSpPr/>
          <p:nvPr/>
        </p:nvSpPr>
        <p:spPr>
          <a:xfrm>
            <a:off x="684360" y="1017000"/>
            <a:ext cx="7704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HY견고딕"/>
              </a:rPr>
              <a:t>Table 1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HY견고딕"/>
              </a:rPr>
              <a:t> List of primers used for RT-PCR and qRT-PCR. Fourteen genes from different categories were chosen for RT-PCR and qRT-PCR analyses. The gene for </a:t>
            </a:r>
            <a:r>
              <a:rPr b="1" i="1" lang="el-GR" sz="1400" spc="-1" strike="noStrike">
                <a:solidFill>
                  <a:srgbClr val="000000"/>
                </a:solidFill>
                <a:latin typeface="Times New Roman"/>
                <a:ea typeface="바탕체"/>
              </a:rPr>
              <a:t>β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HY견고딕"/>
              </a:rPr>
              <a:t>-actin was used as the endogenous control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직사각형 2"/>
          <p:cNvSpPr/>
          <p:nvPr/>
        </p:nvSpPr>
        <p:spPr>
          <a:xfrm>
            <a:off x="338400" y="6000840"/>
            <a:ext cx="8417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ontology of biological process and molecular function. Genes distribution of &gt;2-fold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fferentially expressed genes  between N-eCG and R-eCG.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2" name="Chart 1" descr=""/>
          <p:cNvPicPr/>
          <p:nvPr/>
        </p:nvPicPr>
        <p:blipFill>
          <a:blip r:embed="rId1"/>
          <a:stretch/>
        </p:blipFill>
        <p:spPr>
          <a:xfrm>
            <a:off x="176040" y="1841400"/>
            <a:ext cx="4292640" cy="3969000"/>
          </a:xfrm>
          <a:prstGeom prst="rect">
            <a:avLst/>
          </a:prstGeom>
          <a:ln w="0">
            <a:noFill/>
          </a:ln>
        </p:spPr>
      </p:pic>
      <p:pic>
        <p:nvPicPr>
          <p:cNvPr id="53" name="Chart 1" descr=""/>
          <p:cNvPicPr/>
          <p:nvPr/>
        </p:nvPicPr>
        <p:blipFill>
          <a:blip r:embed="rId2"/>
          <a:stretch/>
        </p:blipFill>
        <p:spPr>
          <a:xfrm>
            <a:off x="4572000" y="1841400"/>
            <a:ext cx="4286160" cy="3969000"/>
          </a:xfrm>
          <a:prstGeom prst="rect">
            <a:avLst/>
          </a:prstGeom>
          <a:ln w="0">
            <a:noFill/>
          </a:ln>
        </p:spPr>
      </p:pic>
      <p:sp>
        <p:nvSpPr>
          <p:cNvPr id="54" name="직사각형 13"/>
          <p:cNvSpPr/>
          <p:nvPr/>
        </p:nvSpPr>
        <p:spPr>
          <a:xfrm>
            <a:off x="2679480" y="5553000"/>
            <a:ext cx="127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굴림"/>
              </a:rPr>
              <a:t>Number of gene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직사각형 14"/>
          <p:cNvSpPr/>
          <p:nvPr/>
        </p:nvSpPr>
        <p:spPr>
          <a:xfrm>
            <a:off x="6892200" y="5551560"/>
            <a:ext cx="127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굴림"/>
              </a:rPr>
              <a:t>Number of gene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TextBox 13"/>
          <p:cNvSpPr/>
          <p:nvPr/>
        </p:nvSpPr>
        <p:spPr>
          <a:xfrm>
            <a:off x="142920" y="142920"/>
            <a:ext cx="62863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HY견고딕"/>
                <a:ea typeface="HY견고딕"/>
              </a:rPr>
              <a:t>Supplementary Fig. 1</a:t>
            </a:r>
            <a:endParaRPr b="0" lang="en-US" sz="2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직사각형 13"/>
          <p:cNvSpPr/>
          <p:nvPr/>
        </p:nvSpPr>
        <p:spPr>
          <a:xfrm>
            <a:off x="1149120" y="1357200"/>
            <a:ext cx="200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logical Process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직사각형 14"/>
          <p:cNvSpPr/>
          <p:nvPr/>
        </p:nvSpPr>
        <p:spPr>
          <a:xfrm>
            <a:off x="5508360" y="1357200"/>
            <a:ext cx="217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lecular Function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차트 1" descr=""/>
          <p:cNvPicPr/>
          <p:nvPr/>
        </p:nvPicPr>
        <p:blipFill>
          <a:blip r:embed="rId1"/>
          <a:stretch/>
        </p:blipFill>
        <p:spPr>
          <a:xfrm>
            <a:off x="139680" y="1712880"/>
            <a:ext cx="4572000" cy="3571920"/>
          </a:xfrm>
          <a:prstGeom prst="rect">
            <a:avLst/>
          </a:prstGeom>
          <a:ln w="0">
            <a:noFill/>
          </a:ln>
        </p:spPr>
      </p:pic>
      <p:sp>
        <p:nvSpPr>
          <p:cNvPr id="60" name="TextBox 13"/>
          <p:cNvSpPr/>
          <p:nvPr/>
        </p:nvSpPr>
        <p:spPr>
          <a:xfrm>
            <a:off x="142920" y="142920"/>
            <a:ext cx="62863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HY견고딕"/>
                <a:ea typeface="HY견고딕"/>
              </a:rPr>
              <a:t>Supplementary Fig. 2</a:t>
            </a:r>
            <a:endParaRPr b="0" lang="en-US" sz="2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1" name="차트 3" descr=""/>
          <p:cNvPicPr/>
          <p:nvPr/>
        </p:nvPicPr>
        <p:blipFill>
          <a:blip r:embed="rId2"/>
          <a:stretch/>
        </p:blipFill>
        <p:spPr>
          <a:xfrm>
            <a:off x="4900680" y="1712880"/>
            <a:ext cx="4243320" cy="3371760"/>
          </a:xfrm>
          <a:prstGeom prst="rect">
            <a:avLst/>
          </a:prstGeom>
          <a:ln w="0">
            <a:noFill/>
          </a:ln>
        </p:spPr>
      </p:pic>
      <p:sp>
        <p:nvSpPr>
          <p:cNvPr id="62" name="직사각형 2"/>
          <p:cNvSpPr/>
          <p:nvPr/>
        </p:nvSpPr>
        <p:spPr>
          <a:xfrm>
            <a:off x="236880" y="5000760"/>
            <a:ext cx="8578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2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ontology of biological process and molecular function. Gene ontology pie diagram of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gt;2-fold differentially expressed genes between N-eCG and R-eCG-treated ovarian. The up-regulated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 down-regulated genes are categorized by the GO term “ biological process and molecular function.”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직사각형 7"/>
          <p:cNvSpPr/>
          <p:nvPr/>
        </p:nvSpPr>
        <p:spPr>
          <a:xfrm>
            <a:off x="1365120" y="1214280"/>
            <a:ext cx="200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logical Process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4" name="직사각형 8"/>
          <p:cNvSpPr/>
          <p:nvPr/>
        </p:nvSpPr>
        <p:spPr>
          <a:xfrm>
            <a:off x="5724000" y="1214280"/>
            <a:ext cx="217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lecular Function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1-29T01:38:26Z</dcterms:created>
  <dc:creator>미롱</dc:creator>
  <dc:description/>
  <dc:language>en-US</dc:language>
  <cp:lastModifiedBy>민관식</cp:lastModifiedBy>
  <dcterms:modified xsi:type="dcterms:W3CDTF">2020-08-23T11:27:17Z</dcterms:modified>
  <cp:revision>167</cp:revision>
  <dc:subject/>
  <dc:title>슬라이드 1</dc:title>
</cp:coreProperties>
</file>